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2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26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2CEB98-940D-4F98-A7C9-4815B2A6AE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A94B03E-624E-42F0-91FA-3F148AA3B5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AE9ED-96C0-48D6-A94D-B0AB156C61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7738D1-5B12-4271-87DC-A0262FA43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0074BF-D59F-4126-8BA6-228CE8520F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065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43579B-2C6D-4504-8AB4-AD2FFCA9DF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72BB89-F34B-42B7-8F83-70BF44F948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104717-E77C-46CD-9B7F-4FEBEF50A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1B57E8-8DED-4B10-8220-88644D82A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117524-101B-4182-B755-DB627FC4C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1364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AA361CD-81DB-43B2-8C0D-5419B76723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8A85B69-E402-4375-980A-3CE4626AE7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C0BC10-EC1A-4DBC-AF72-60E133E86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9D2827-B97C-4D31-9D49-D3852D5BF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B68B93-2A0F-4DB1-8C2E-1D766F882D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866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526316-706B-4B03-BEB2-CC4F447438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518E2F-547E-4E82-BF79-1D2904CE10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C27EBD-A775-4C31-8AFB-2A7AD2460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15772D-85C9-44BA-AE2D-6732C3B1E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D917A-6A72-4E68-B917-425894B35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146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7F54F-4854-42CE-850C-AF0A26A073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398A84-6614-4FF5-8500-8ACBAFD0E2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54634D-7A14-41A5-B390-50D01D5380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8EC522-169A-43EA-B621-65D79F66B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904B2A-0315-4D30-A105-36C8E5598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762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D09B30-1195-4C2B-B7AC-45BE28FC77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24F26A-09EF-405E-B2AC-60E558468AE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4E60D0-6E6E-4037-8DC9-6D7CBFE012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FC368B9-3CE3-4DF3-9266-FB9C3388B2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92EBFB-FD37-4009-87B7-47B8DC681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AAA803-E93C-4145-9A1F-8255EEE75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740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738F1-6D05-4FBE-948D-1359EAF21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C59492-7A89-41E6-A5B9-AE453FD184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8B63B5-8BC4-46D3-B0AA-80859088D6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9B61EAF-760F-4A8A-829B-4412E6BB5E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EF3C91-DAB8-4112-A2C1-C9F8AECC33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651691-20F4-459E-9D48-EE860749A8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14F489D-6BDF-4DED-B743-091BC7CF3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49D49A-DC22-4DE6-BC75-1EB27AEE1E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266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3A73F0-7F4B-4CC5-BFA7-902A84DB04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D5FF02E-9828-4FDE-A79E-4E241D55D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06DACB-6FB6-44C6-BA14-8FA154461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FD2712D-FA35-4664-81FF-7421A44ED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449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AC16B3F-44F6-4EFA-BEFB-22FDB926D5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A3098EF-A8E7-4F81-A2C5-3FB6129C8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4A45E4-7B90-4CF5-B6A8-CA86026B43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6534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4B487-4B4D-474C-93C4-7FD2CECA35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4F5030-7507-491D-960E-B758492C6C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A374A9-BD07-43C3-B4D8-76EBAA04AA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65463F-D163-4591-A2BF-A2BF13AAA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45A87D-737A-4AB0-ADAB-1AE26F07D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CD5C649-6956-49CD-9EAD-8F9382BA3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498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0DC0CA-353B-4E93-988A-D0CAAF5CD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A481E7-AC00-4F09-A187-48E473175D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E31487-2E43-4EF8-B9AD-93D76990C6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FFEBBE-7832-49DE-A9CD-3241021E8A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790B8E-480C-4DD3-A8A7-53973018EF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79F17C-B069-483D-8838-279612EFD1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57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8A89F73-114C-4D0E-9233-4C1D4DF0DE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D29F70-F74F-43ED-856A-C0A66EB68A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A0A67-F3B6-4D88-8F22-73F884D66A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F4715-A536-47E7-967C-9792285CCED9}" type="datetimeFigureOut">
              <a:rPr lang="en-US" smtClean="0"/>
              <a:t>11/21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F7FD56-8F05-4B82-B1CF-C678443F83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B5BA83-082E-429D-9727-1ADA450213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8B17A1-A8E4-4107-8871-D6AE785635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322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9B802916-9E92-430C-88A8-19C154A110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US"/>
          </a:p>
        </p:txBody>
      </p:sp>
      <p:pic>
        <p:nvPicPr>
          <p:cNvPr id="1025" name="Picture 16">
            <a:extLst>
              <a:ext uri="{FF2B5EF4-FFF2-40B4-BE49-F238E27FC236}">
                <a16:creationId xmlns:a16="http://schemas.microsoft.com/office/drawing/2014/main" id="{EC3E28B9-4CC8-44C0-B231-F21AA6890FD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2324" y="272534"/>
            <a:ext cx="11087352" cy="58064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7B1B3C8-0338-4C03-9431-3CF639084895}"/>
              </a:ext>
            </a:extLst>
          </p:cNvPr>
          <p:cNvSpPr txBox="1"/>
          <p:nvPr/>
        </p:nvSpPr>
        <p:spPr>
          <a:xfrm>
            <a:off x="485505" y="6053130"/>
            <a:ext cx="112151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9. </a:t>
            </a:r>
            <a:r>
              <a:rPr lang="en-US" alt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ft: Ultrasonic humidification chamber set up for ripening compound and control solution administration. Humidification is conducted over a period of 16 hours. Top right: Vacuum aspiration chamber used for internal ethylene gas extraction. Bottom right: Respiration monitoring system. Individual jars represent a single treatment and one of four technical replicates.</a:t>
            </a:r>
            <a:endParaRPr kumimoji="0" lang="en-US" altLang="en-US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144516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6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anna</dc:creator>
  <cp:lastModifiedBy>Seanna</cp:lastModifiedBy>
  <cp:revision>2</cp:revision>
  <dcterms:created xsi:type="dcterms:W3CDTF">2019-11-21T16:35:47Z</dcterms:created>
  <dcterms:modified xsi:type="dcterms:W3CDTF">2019-11-21T23:52:55Z</dcterms:modified>
</cp:coreProperties>
</file>